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4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147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131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330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410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700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201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42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6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975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739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352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Enterobacteria_otherL6_PC1vsPC3plot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570" y="905858"/>
            <a:ext cx="3533296" cy="264997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932153" y="491420"/>
            <a:ext cx="327413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 err="1"/>
              <a:t>Enterobacteriaceae</a:t>
            </a:r>
            <a:r>
              <a:rPr lang="en-US" sz="1350" dirty="0" err="1"/>
              <a:t>_other</a:t>
            </a:r>
            <a:endParaRPr lang="en-US" sz="1350" dirty="0"/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pic>
        <p:nvPicPr>
          <p:cNvPr id="4" name="Picture 3" descr="StrepL6_PC1vsPC3plot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1978" y="915994"/>
            <a:ext cx="3533296" cy="264997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50485" y="491419"/>
            <a:ext cx="341478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/>
              <a:t>Streptococcus</a:t>
            </a:r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pic>
        <p:nvPicPr>
          <p:cNvPr id="7" name="Picture 6" descr="Clostridiaceae_otherL6_PC1vsPC3plot.eps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0124" y="3924650"/>
            <a:ext cx="3533296" cy="264997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186055" y="3546264"/>
            <a:ext cx="294364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 err="1"/>
              <a:t>Clostridiaceae</a:t>
            </a:r>
            <a:r>
              <a:rPr lang="en-US" sz="1350" dirty="0" err="1"/>
              <a:t>_other</a:t>
            </a:r>
            <a:endParaRPr lang="en-US" sz="1350" dirty="0"/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pic>
        <p:nvPicPr>
          <p:cNvPr id="9" name="Picture 8" descr="E_coli_ShigellaL6_PC1vsPC3plot.eps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718" y="3924652"/>
            <a:ext cx="3533296" cy="264997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138208" y="3546264"/>
            <a:ext cx="309353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/>
              <a:t>Escherichia/</a:t>
            </a:r>
            <a:r>
              <a:rPr lang="en-US" sz="1350" i="1" dirty="0" err="1"/>
              <a:t>Shigella</a:t>
            </a:r>
            <a:endParaRPr lang="en-US" sz="1350" i="1" dirty="0"/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4112955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</TotalTime>
  <Words>40</Words>
  <Application>Microsoft Office PowerPoint</Application>
  <PresentationFormat>Letter Paper (8.5x11 in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7</cp:revision>
  <dcterms:created xsi:type="dcterms:W3CDTF">2014-09-02T01:12:04Z</dcterms:created>
  <dcterms:modified xsi:type="dcterms:W3CDTF">2015-01-19T21:52:57Z</dcterms:modified>
</cp:coreProperties>
</file>